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4524" autoAdjust="0"/>
  </p:normalViewPr>
  <p:slideViewPr>
    <p:cSldViewPr snapToGrid="0" snapToObjects="1">
      <p:cViewPr>
        <p:scale>
          <a:sx n="60" d="100"/>
          <a:sy n="60" d="100"/>
        </p:scale>
        <p:origin x="-2274" y="-5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fnolan\Dropbox\anophele\Article\qPCRvsRNA-seq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fnolan\Dropbox\anophele\Copy%20of%20RT-qPCR%20analysis%20(vs%20carcass)%20(2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/>
              <a:t>qPCR validation of</a:t>
            </a:r>
            <a:r>
              <a:rPr lang="en-US" sz="1400" baseline="0"/>
              <a:t> differentially expressed miRNAs</a:t>
            </a:r>
            <a:endParaRPr lang="en-US" sz="1400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E$1</c:f>
              <c:strCache>
                <c:ptCount val="1"/>
                <c:pt idx="0">
                  <c:v>qPCR log2 Fold change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1"/>
            <c:dispEq val="0"/>
            <c:trendlineLbl>
              <c:layout/>
              <c:numFmt formatCode="General" sourceLinked="0"/>
            </c:trendlineLbl>
          </c:trendline>
          <c:xVal>
            <c:numRef>
              <c:f>Sheet1!$C$2:$C$13</c:f>
              <c:numCache>
                <c:formatCode>General</c:formatCode>
                <c:ptCount val="12"/>
                <c:pt idx="0">
                  <c:v>-6.72</c:v>
                </c:pt>
                <c:pt idx="1">
                  <c:v>6.87</c:v>
                </c:pt>
                <c:pt idx="2">
                  <c:v>1.87</c:v>
                </c:pt>
                <c:pt idx="3">
                  <c:v>8.2799999999999994</c:v>
                </c:pt>
                <c:pt idx="4">
                  <c:v>6.2</c:v>
                </c:pt>
                <c:pt idx="5">
                  <c:v>2</c:v>
                </c:pt>
                <c:pt idx="6">
                  <c:v>8.15</c:v>
                </c:pt>
                <c:pt idx="7">
                  <c:v>5.94</c:v>
                </c:pt>
                <c:pt idx="8">
                  <c:v>4.96</c:v>
                </c:pt>
                <c:pt idx="9">
                  <c:v>-5.19</c:v>
                </c:pt>
                <c:pt idx="10">
                  <c:v>5.74</c:v>
                </c:pt>
                <c:pt idx="11">
                  <c:v>-6.56</c:v>
                </c:pt>
              </c:numCache>
            </c:numRef>
          </c:xVal>
          <c:yVal>
            <c:numRef>
              <c:f>Sheet1!$E$2:$E$13</c:f>
              <c:numCache>
                <c:formatCode>General</c:formatCode>
                <c:ptCount val="12"/>
                <c:pt idx="0">
                  <c:v>-3.82</c:v>
                </c:pt>
                <c:pt idx="1">
                  <c:v>2.66</c:v>
                </c:pt>
                <c:pt idx="2">
                  <c:v>3.37</c:v>
                </c:pt>
                <c:pt idx="3">
                  <c:v>5.68</c:v>
                </c:pt>
                <c:pt idx="4">
                  <c:v>2.3199999999999998</c:v>
                </c:pt>
                <c:pt idx="5">
                  <c:v>3.49</c:v>
                </c:pt>
                <c:pt idx="6">
                  <c:v>4.6900000000000004</c:v>
                </c:pt>
                <c:pt idx="7">
                  <c:v>1.2</c:v>
                </c:pt>
                <c:pt idx="8">
                  <c:v>7.05</c:v>
                </c:pt>
                <c:pt idx="9">
                  <c:v>-10.45</c:v>
                </c:pt>
                <c:pt idx="10">
                  <c:v>7.82</c:v>
                </c:pt>
                <c:pt idx="11">
                  <c:v>-7.8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165056"/>
        <c:axId val="97671040"/>
      </c:scatterChart>
      <c:valAx>
        <c:axId val="951650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qPCR (log 2)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7671040"/>
        <c:crosses val="autoZero"/>
        <c:crossBetween val="midCat"/>
      </c:valAx>
      <c:valAx>
        <c:axId val="97671040"/>
        <c:scaling>
          <c:orientation val="minMax"/>
        </c:scaling>
        <c:delete val="0"/>
        <c:axPos val="l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GB"/>
                  <a:t>RNA-Seq (log2)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516505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/>
              <a:t>Testis-biased</a:t>
            </a:r>
            <a:r>
              <a:rPr lang="en-GB" baseline="0"/>
              <a:t> miRNAs</a:t>
            </a:r>
            <a:endParaRPr lang="en-GB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5198862642169728"/>
          <c:y val="0.30629848352289296"/>
          <c:w val="0.69801137357830279"/>
          <c:h val="0.57772163896179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J$4</c:f>
              <c:strCache>
                <c:ptCount val="1"/>
                <c:pt idx="0">
                  <c:v>TE/Carcass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ummary!$K$5:$K$6</c:f>
                <c:numCache>
                  <c:formatCode>General</c:formatCode>
                  <c:ptCount val="2"/>
                  <c:pt idx="0">
                    <c:v>0.10959434509277344</c:v>
                  </c:pt>
                  <c:pt idx="1">
                    <c:v>0.458860397338867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ummary!$I$5:$I$6</c:f>
              <c:strCache>
                <c:ptCount val="2"/>
                <c:pt idx="0">
                  <c:v>X_43358</c:v>
                </c:pt>
                <c:pt idx="1">
                  <c:v>X_43370</c:v>
                </c:pt>
              </c:strCache>
            </c:strRef>
          </c:cat>
          <c:val>
            <c:numRef>
              <c:f>summary!$J$5:$J$6</c:f>
              <c:numCache>
                <c:formatCode>General</c:formatCode>
                <c:ptCount val="2"/>
                <c:pt idx="0">
                  <c:v>9.4470062255859375</c:v>
                </c:pt>
                <c:pt idx="1">
                  <c:v>10.5573081970214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7679616"/>
        <c:axId val="97685504"/>
      </c:barChart>
      <c:catAx>
        <c:axId val="97679616"/>
        <c:scaling>
          <c:orientation val="minMax"/>
        </c:scaling>
        <c:delete val="0"/>
        <c:axPos val="b"/>
        <c:majorTickMark val="out"/>
        <c:minorTickMark val="none"/>
        <c:tickLblPos val="nextTo"/>
        <c:crossAx val="97685504"/>
        <c:crosses val="autoZero"/>
        <c:auto val="1"/>
        <c:lblAlgn val="ctr"/>
        <c:lblOffset val="100"/>
        <c:noMultiLvlLbl val="0"/>
      </c:catAx>
      <c:valAx>
        <c:axId val="9768550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dirty="0"/>
                  <a:t>log2</a:t>
                </a:r>
                <a:r>
                  <a:rPr lang="en-GB" baseline="0" dirty="0"/>
                  <a:t> fold enrichment  (</a:t>
                </a:r>
                <a:r>
                  <a:rPr lang="el-GR" baseline="0" dirty="0">
                    <a:latin typeface="Calibri"/>
                    <a:cs typeface="Calibri"/>
                  </a:rPr>
                  <a:t>ΔΔ</a:t>
                </a:r>
                <a:r>
                  <a:rPr lang="en-GB" baseline="0" dirty="0">
                    <a:latin typeface="Calibri"/>
                    <a:cs typeface="Calibri"/>
                  </a:rPr>
                  <a:t>Ct)</a:t>
                </a:r>
                <a:endParaRPr lang="en-GB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7679616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257F5A-3AFB-594C-9A5B-23BC3E10F2CF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620022-3215-B540-8CE1-5ABEDB351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929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042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266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141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111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397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243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768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822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383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661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09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019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10267"/>
              </p:ext>
            </p:extLst>
          </p:nvPr>
        </p:nvGraphicFramePr>
        <p:xfrm>
          <a:off x="1259632" y="218356"/>
          <a:ext cx="6754068" cy="327736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99887"/>
                <a:gridCol w="1435667"/>
                <a:gridCol w="1814900"/>
                <a:gridCol w="1178331"/>
                <a:gridCol w="1625283"/>
              </a:tblGrid>
              <a:tr h="20955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 smtClean="0">
                          <a:effectLst/>
                        </a:rPr>
                        <a:t>miRNA</a:t>
                      </a:r>
                      <a:r>
                        <a:rPr lang="en-GB" sz="1100" smtClean="0">
                          <a:effectLst/>
                        </a:rPr>
                        <a:t> 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Samples Compared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RNASeq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( log2 Fold change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-value (DESeq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qPCR 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(log2 Fold change)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mIR-989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TE/OV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-6.72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9.40E-007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-3.8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F/T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6.87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2.41E-0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2.6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aga-mir-2944a-2</a:t>
                      </a: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E/OV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1.87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8.57E-0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3.37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F/OV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8.28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2.21E-0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5.68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F/T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6.2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2.86E-0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2.3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aga-mir-286b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E/OV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2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.43E-0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3.49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F/OV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8.15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7.50E-03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4.69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F/T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5.94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2.86E-02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.2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/>
                        <a:t>aga-mir-10361b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E/OV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4.9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9.58E-13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7.0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BF/TE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-5.19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4.25E-05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-10.45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190500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aga-mir-10355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E/OV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5.74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3.14E-29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7.82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200025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BF/TE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-6.5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.97E-06</a:t>
                      </a:r>
                      <a:endParaRPr lang="en-GB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-7.89</a:t>
                      </a:r>
                      <a:endParaRPr lang="en-GB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</a:tbl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3974312"/>
              </p:ext>
            </p:extLst>
          </p:nvPr>
        </p:nvGraphicFramePr>
        <p:xfrm>
          <a:off x="0" y="3573016"/>
          <a:ext cx="5148064" cy="23111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9620" y="6494678"/>
            <a:ext cx="47595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smtClean="0"/>
              <a:t>Additional File 6 qPCR</a:t>
            </a:r>
            <a:r>
              <a:rPr lang="en-GB" sz="1400" b="1" dirty="0" smtClean="0"/>
              <a:t> </a:t>
            </a:r>
            <a:r>
              <a:rPr lang="en-GB" sz="1400" b="1" dirty="0" smtClean="0"/>
              <a:t>validation of </a:t>
            </a:r>
            <a:r>
              <a:rPr lang="en-GB" sz="1400" b="1" dirty="0" err="1" smtClean="0"/>
              <a:t>miRNA</a:t>
            </a:r>
            <a:r>
              <a:rPr lang="en-GB" sz="1400" b="1" dirty="0" smtClean="0"/>
              <a:t> expression profiles</a:t>
            </a:r>
            <a:endParaRPr lang="en-GB" sz="14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44321" y="191502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4321" y="359769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9" name="TextBox 8"/>
          <p:cNvSpPr txBox="1"/>
          <p:nvPr/>
        </p:nvSpPr>
        <p:spPr>
          <a:xfrm>
            <a:off x="5148064" y="3597697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grpSp>
        <p:nvGrpSpPr>
          <p:cNvPr id="12" name="Group 11"/>
          <p:cNvGrpSpPr/>
          <p:nvPr/>
        </p:nvGrpSpPr>
        <p:grpSpPr>
          <a:xfrm>
            <a:off x="5148064" y="3573016"/>
            <a:ext cx="4572000" cy="2743200"/>
            <a:chOff x="5148064" y="3573016"/>
            <a:chExt cx="4572000" cy="2743200"/>
          </a:xfrm>
        </p:grpSpPr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13833243"/>
                </p:ext>
              </p:extLst>
            </p:nvPr>
          </p:nvGraphicFramePr>
          <p:xfrm>
            <a:off x="5148064" y="3573016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" name="Rectangle 3"/>
            <p:cNvSpPr/>
            <p:nvPr/>
          </p:nvSpPr>
          <p:spPr>
            <a:xfrm>
              <a:off x="6018432" y="6033234"/>
              <a:ext cx="1178849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GB" sz="1200" dirty="0"/>
                <a:t>aga-mir-10361b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7655728" y="6033234"/>
              <a:ext cx="109869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GB" sz="1200" dirty="0"/>
                <a:t>aga-mir-1035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02913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41</TotalTime>
  <Words>120</Words>
  <Application>Microsoft Office PowerPoint</Application>
  <PresentationFormat>On-screen Show (4:3)</PresentationFormat>
  <Paragraphs>7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andro Castellano</dc:creator>
  <cp:lastModifiedBy>tfnolan</cp:lastModifiedBy>
  <cp:revision>37</cp:revision>
  <dcterms:created xsi:type="dcterms:W3CDTF">2014-01-30T12:03:48Z</dcterms:created>
  <dcterms:modified xsi:type="dcterms:W3CDTF">2014-12-09T17:43:31Z</dcterms:modified>
</cp:coreProperties>
</file>